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10"/>
  </p:notesMasterIdLst>
  <p:sldIdLst>
    <p:sldId id="271" r:id="rId2"/>
    <p:sldId id="266" r:id="rId3"/>
    <p:sldId id="264" r:id="rId4"/>
    <p:sldId id="272" r:id="rId5"/>
    <p:sldId id="270" r:id="rId6"/>
    <p:sldId id="268" r:id="rId7"/>
    <p:sldId id="269" r:id="rId8"/>
    <p:sldId id="261" r:id="rId9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41100"/>
    <a:srgbClr val="89D761"/>
    <a:srgbClr val="F8E32F"/>
    <a:srgbClr val="541263"/>
    <a:srgbClr val="942193"/>
    <a:srgbClr val="008E4F"/>
    <a:srgbClr val="9437FF"/>
    <a:srgbClr val="9337FE"/>
    <a:srgbClr val="A8A9A9"/>
    <a:srgbClr val="57136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161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12272F5-7EC2-3147-9CE5-F731DEDD5CF1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4322BA3-D07A-784B-9866-198AC56371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186477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4322BA3-D07A-784B-9866-198AC56371A3}" type="slidenum">
              <a:rPr lang="en-GB" smtClean="0"/>
              <a:t>8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28173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02602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706208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778571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81238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78693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807957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632308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22365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87079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83159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D3B60C-24E4-164F-A368-FCBE0E94B0C7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115190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D3B60C-24E4-164F-A368-FCBE0E94B0C7}" type="datetimeFigureOut">
              <a:rPr lang="en-GB" smtClean="0"/>
              <a:t>05/09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04B00B-0FCE-9C4B-AA36-16A2C41520A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31552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emf"/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.png"/><Relationship Id="rId5" Type="http://schemas.openxmlformats.org/officeDocument/2006/relationships/image" Target="../media/image7.png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6.emf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emf"/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1.emf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27.emf"/><Relationship Id="rId13" Type="http://schemas.openxmlformats.org/officeDocument/2006/relationships/image" Target="../media/image32.emf"/><Relationship Id="rId3" Type="http://schemas.openxmlformats.org/officeDocument/2006/relationships/image" Target="../media/image22.emf"/><Relationship Id="rId7" Type="http://schemas.openxmlformats.org/officeDocument/2006/relationships/image" Target="../media/image26.emf"/><Relationship Id="rId12" Type="http://schemas.openxmlformats.org/officeDocument/2006/relationships/image" Target="../media/image3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emf"/><Relationship Id="rId11" Type="http://schemas.openxmlformats.org/officeDocument/2006/relationships/image" Target="../media/image30.emf"/><Relationship Id="rId5" Type="http://schemas.openxmlformats.org/officeDocument/2006/relationships/image" Target="../media/image24.emf"/><Relationship Id="rId10" Type="http://schemas.openxmlformats.org/officeDocument/2006/relationships/image" Target="../media/image29.emf"/><Relationship Id="rId4" Type="http://schemas.openxmlformats.org/officeDocument/2006/relationships/image" Target="../media/image23.emf"/><Relationship Id="rId9" Type="http://schemas.openxmlformats.org/officeDocument/2006/relationships/image" Target="../media/image2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47B07B96-C915-1887-D9F8-718678511396}"/>
              </a:ext>
            </a:extLst>
          </p:cNvPr>
          <p:cNvSpPr txBox="1"/>
          <p:nvPr/>
        </p:nvSpPr>
        <p:spPr>
          <a:xfrm>
            <a:off x="169817" y="287383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1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11F1B1F-1B8A-00E0-EAFD-8DC85F303533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755" b="50000"/>
          <a:stretch/>
        </p:blipFill>
        <p:spPr>
          <a:xfrm>
            <a:off x="1314249" y="2923262"/>
            <a:ext cx="7772400" cy="174941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AC28588C-3629-4A68-FCB0-813F652603D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t="5755" b="50000"/>
          <a:stretch/>
        </p:blipFill>
        <p:spPr>
          <a:xfrm>
            <a:off x="1314249" y="4821207"/>
            <a:ext cx="7772400" cy="174941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A026CA2-A537-4E1D-E296-CEB103CBB732}"/>
              </a:ext>
            </a:extLst>
          </p:cNvPr>
          <p:cNvSpPr txBox="1"/>
          <p:nvPr/>
        </p:nvSpPr>
        <p:spPr>
          <a:xfrm rot="16200000">
            <a:off x="129312" y="3644078"/>
            <a:ext cx="1749410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/>
              <a:t>PSEN1 R278I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217AE3E0-E999-1826-987B-1494DF0B10A3}"/>
              </a:ext>
            </a:extLst>
          </p:cNvPr>
          <p:cNvSpPr txBox="1"/>
          <p:nvPr/>
        </p:nvSpPr>
        <p:spPr>
          <a:xfrm rot="16200000">
            <a:off x="129312" y="5542023"/>
            <a:ext cx="1749410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/>
              <a:t>Isogenic corrected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C4C4262D-1436-4319-A90E-899F4832AC1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43440" y="869107"/>
            <a:ext cx="4755169" cy="1729152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89BD9DD8-22E8-69BB-C9A1-3014518052C8}"/>
              </a:ext>
            </a:extLst>
          </p:cNvPr>
          <p:cNvSpPr/>
          <p:nvPr/>
        </p:nvSpPr>
        <p:spPr>
          <a:xfrm>
            <a:off x="4948779" y="702160"/>
            <a:ext cx="233916" cy="2030448"/>
          </a:xfrm>
          <a:prstGeom prst="rect">
            <a:avLst/>
          </a:prstGeom>
          <a:noFill/>
          <a:ln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8150920-9E8E-5D8F-33D7-3355FE9A0E0E}"/>
              </a:ext>
            </a:extLst>
          </p:cNvPr>
          <p:cNvSpPr txBox="1"/>
          <p:nvPr/>
        </p:nvSpPr>
        <p:spPr>
          <a:xfrm>
            <a:off x="4279368" y="332828"/>
            <a:ext cx="1572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T&gt;G correction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7DD3558-E4D0-BE1C-19C1-B99BF379C397}"/>
              </a:ext>
            </a:extLst>
          </p:cNvPr>
          <p:cNvSpPr txBox="1"/>
          <p:nvPr/>
        </p:nvSpPr>
        <p:spPr>
          <a:xfrm rot="16200000">
            <a:off x="144410" y="1573623"/>
            <a:ext cx="1729153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/>
              <a:t>Isogenic corrected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C6691C6-F4EE-C85A-BD02-AC23CE6921F2}"/>
              </a:ext>
            </a:extLst>
          </p:cNvPr>
          <p:cNvSpPr txBox="1"/>
          <p:nvPr/>
        </p:nvSpPr>
        <p:spPr>
          <a:xfrm>
            <a:off x="850128" y="540835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A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AD64BE3-0699-5FE5-659A-C2E03DC0F0BD}"/>
              </a:ext>
            </a:extLst>
          </p:cNvPr>
          <p:cNvSpPr txBox="1"/>
          <p:nvPr/>
        </p:nvSpPr>
        <p:spPr>
          <a:xfrm>
            <a:off x="850128" y="259682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8646757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B9F717E8-8B4B-B4F4-D8EF-3E164EEEABA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t="20141" r="4165" b="38475"/>
          <a:stretch/>
        </p:blipFill>
        <p:spPr>
          <a:xfrm>
            <a:off x="827242" y="1958801"/>
            <a:ext cx="2416104" cy="26449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B2E5D4F-5766-5C40-100D-F0369305DCE6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4164"/>
          <a:stretch/>
        </p:blipFill>
        <p:spPr>
          <a:xfrm>
            <a:off x="827239" y="2653674"/>
            <a:ext cx="2416105" cy="332417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9A7BDC1-4E93-ACE4-00D0-BC69FBCBC8E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844" t="31285" r="320" b="18548"/>
          <a:stretch/>
        </p:blipFill>
        <p:spPr>
          <a:xfrm>
            <a:off x="827240" y="2269555"/>
            <a:ext cx="2416105" cy="332419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FF03C5FE-7688-D0B9-99B6-DEE8025B3669}"/>
              </a:ext>
            </a:extLst>
          </p:cNvPr>
          <p:cNvSpPr txBox="1"/>
          <p:nvPr/>
        </p:nvSpPr>
        <p:spPr>
          <a:xfrm>
            <a:off x="3262028" y="1972113"/>
            <a:ext cx="53732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/>
              <a:t>PSEN1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86D37FC7-4D6B-D7A5-8501-C020ADF8F67E}"/>
              </a:ext>
            </a:extLst>
          </p:cNvPr>
          <p:cNvSpPr txBox="1"/>
          <p:nvPr/>
        </p:nvSpPr>
        <p:spPr>
          <a:xfrm>
            <a:off x="3262028" y="2308098"/>
            <a:ext cx="53732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/>
              <a:t>PSEN2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A153D83-7386-6581-793A-AA15B683EE6A}"/>
              </a:ext>
            </a:extLst>
          </p:cNvPr>
          <p:cNvSpPr txBox="1"/>
          <p:nvPr/>
        </p:nvSpPr>
        <p:spPr>
          <a:xfrm>
            <a:off x="3262029" y="2739167"/>
            <a:ext cx="58381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/>
              <a:t>GAPDH</a:t>
            </a:r>
          </a:p>
        </p:txBody>
      </p:sp>
      <p:pic>
        <p:nvPicPr>
          <p:cNvPr id="12" name="Picture 11" descr="A picture containing text, appliance&#10;&#10;Description automatically generated">
            <a:extLst>
              <a:ext uri="{FF2B5EF4-FFF2-40B4-BE49-F238E27FC236}">
                <a16:creationId xmlns:a16="http://schemas.microsoft.com/office/drawing/2014/main" id="{57E629DC-9472-4521-BF7A-63DE0CC0AD24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r="4165"/>
          <a:stretch/>
        </p:blipFill>
        <p:spPr>
          <a:xfrm>
            <a:off x="827242" y="1447194"/>
            <a:ext cx="2416104" cy="46506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3" name="TextBox 12">
            <a:extLst>
              <a:ext uri="{FF2B5EF4-FFF2-40B4-BE49-F238E27FC236}">
                <a16:creationId xmlns:a16="http://schemas.microsoft.com/office/drawing/2014/main" id="{50740DFC-28AC-408B-C3A7-E1EE8F818B12}"/>
              </a:ext>
            </a:extLst>
          </p:cNvPr>
          <p:cNvSpPr txBox="1"/>
          <p:nvPr/>
        </p:nvSpPr>
        <p:spPr>
          <a:xfrm>
            <a:off x="3262026" y="1548620"/>
            <a:ext cx="401072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/>
              <a:t>APP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A002F4E-D08E-9C80-E2DC-D583D5CEA5E8}"/>
              </a:ext>
            </a:extLst>
          </p:cNvPr>
          <p:cNvSpPr txBox="1"/>
          <p:nvPr/>
        </p:nvSpPr>
        <p:spPr>
          <a:xfrm>
            <a:off x="3262025" y="2563960"/>
            <a:ext cx="46679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50"/>
              <a:t>Actin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EB401F55-C12A-19A9-F50A-77AA3D72E04D}"/>
              </a:ext>
            </a:extLst>
          </p:cNvPr>
          <p:cNvSpPr txBox="1"/>
          <p:nvPr/>
        </p:nvSpPr>
        <p:spPr>
          <a:xfrm rot="16200000">
            <a:off x="886455" y="932417"/>
            <a:ext cx="64953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/>
              <a:t>Neurons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45C7366-D669-40F4-487F-413DFF2B5973}"/>
              </a:ext>
            </a:extLst>
          </p:cNvPr>
          <p:cNvSpPr txBox="1"/>
          <p:nvPr/>
        </p:nvSpPr>
        <p:spPr>
          <a:xfrm rot="16200000">
            <a:off x="1486828" y="889792"/>
            <a:ext cx="761748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/>
              <a:t>Astrocytes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3FEDD8C-E9D0-E904-86B1-C8AA9951374B}"/>
              </a:ext>
            </a:extLst>
          </p:cNvPr>
          <p:cNvSpPr txBox="1"/>
          <p:nvPr/>
        </p:nvSpPr>
        <p:spPr>
          <a:xfrm rot="16200000">
            <a:off x="2157568" y="932417"/>
            <a:ext cx="69442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/>
              <a:t>Microgli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70452E96-2ACB-CF80-6BFA-22EE6F763173}"/>
              </a:ext>
            </a:extLst>
          </p:cNvPr>
          <p:cNvSpPr txBox="1"/>
          <p:nvPr/>
        </p:nvSpPr>
        <p:spPr>
          <a:xfrm rot="16200000">
            <a:off x="2810240" y="1046477"/>
            <a:ext cx="470001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GB" sz="1050"/>
              <a:t>Brain</a:t>
            </a:r>
          </a:p>
        </p:txBody>
      </p:sp>
      <p:cxnSp>
        <p:nvCxnSpPr>
          <p:cNvPr id="19" name="Straight Connector 18">
            <a:extLst>
              <a:ext uri="{FF2B5EF4-FFF2-40B4-BE49-F238E27FC236}">
                <a16:creationId xmlns:a16="http://schemas.microsoft.com/office/drawing/2014/main" id="{33E50E4D-FF9B-D09B-B903-6B35BED65CB5}"/>
              </a:ext>
            </a:extLst>
          </p:cNvPr>
          <p:cNvCxnSpPr>
            <a:cxnSpLocks/>
          </p:cNvCxnSpPr>
          <p:nvPr/>
        </p:nvCxnSpPr>
        <p:spPr>
          <a:xfrm>
            <a:off x="972113" y="1387659"/>
            <a:ext cx="47822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Connector 19">
            <a:extLst>
              <a:ext uri="{FF2B5EF4-FFF2-40B4-BE49-F238E27FC236}">
                <a16:creationId xmlns:a16="http://schemas.microsoft.com/office/drawing/2014/main" id="{DCF9CEEF-9703-F9D3-1F2C-9D1F2297B812}"/>
              </a:ext>
            </a:extLst>
          </p:cNvPr>
          <p:cNvCxnSpPr>
            <a:cxnSpLocks/>
          </p:cNvCxnSpPr>
          <p:nvPr/>
        </p:nvCxnSpPr>
        <p:spPr>
          <a:xfrm>
            <a:off x="1628586" y="1387659"/>
            <a:ext cx="47822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A1FA4039-EC2B-4292-2E58-1C11B617335C}"/>
              </a:ext>
            </a:extLst>
          </p:cNvPr>
          <p:cNvCxnSpPr>
            <a:cxnSpLocks/>
          </p:cNvCxnSpPr>
          <p:nvPr/>
        </p:nvCxnSpPr>
        <p:spPr>
          <a:xfrm>
            <a:off x="2265663" y="1387659"/>
            <a:ext cx="478221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B6EB6F04-977E-3FE3-8F1F-34ADDA4D5E59}"/>
              </a:ext>
            </a:extLst>
          </p:cNvPr>
          <p:cNvCxnSpPr>
            <a:cxnSpLocks/>
          </p:cNvCxnSpPr>
          <p:nvPr/>
        </p:nvCxnSpPr>
        <p:spPr>
          <a:xfrm>
            <a:off x="2897388" y="1387659"/>
            <a:ext cx="295700" cy="0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3" name="Picture 22" descr="A red and green light on a square&#10;&#10;Description automatically generated">
            <a:extLst>
              <a:ext uri="{FF2B5EF4-FFF2-40B4-BE49-F238E27FC236}">
                <a16:creationId xmlns:a16="http://schemas.microsoft.com/office/drawing/2014/main" id="{D08C9C03-04D7-1581-EF12-CF84EC5AEA00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26213" t="39677" r="20340" b="47556"/>
          <a:stretch/>
        </p:blipFill>
        <p:spPr>
          <a:xfrm>
            <a:off x="827242" y="3202165"/>
            <a:ext cx="2055556" cy="41515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24" name="TextBox 23">
            <a:extLst>
              <a:ext uri="{FF2B5EF4-FFF2-40B4-BE49-F238E27FC236}">
                <a16:creationId xmlns:a16="http://schemas.microsoft.com/office/drawing/2014/main" id="{DC208114-BEB8-D944-2690-BD1C1B92504A}"/>
              </a:ext>
            </a:extLst>
          </p:cNvPr>
          <p:cNvSpPr txBox="1"/>
          <p:nvPr/>
        </p:nvSpPr>
        <p:spPr>
          <a:xfrm>
            <a:off x="3262027" y="3199106"/>
            <a:ext cx="761672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050">
                <a:solidFill>
                  <a:srgbClr val="00B050"/>
                </a:solidFill>
              </a:rPr>
              <a:t>sAPPβ </a:t>
            </a:r>
          </a:p>
          <a:p>
            <a:r>
              <a:rPr lang="en-GB" sz="1050">
                <a:solidFill>
                  <a:srgbClr val="FF0000"/>
                </a:solidFill>
              </a:rPr>
              <a:t>sAPP total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40A30B4-DA8E-A6CD-BCC4-AA02FF799FC1}"/>
              </a:ext>
            </a:extLst>
          </p:cNvPr>
          <p:cNvSpPr txBox="1"/>
          <p:nvPr/>
        </p:nvSpPr>
        <p:spPr>
          <a:xfrm>
            <a:off x="169817" y="287383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2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7F6B1895-2A5C-D50E-AC7B-1D59322AC378}"/>
              </a:ext>
            </a:extLst>
          </p:cNvPr>
          <p:cNvSpPr txBox="1"/>
          <p:nvPr/>
        </p:nvSpPr>
        <p:spPr>
          <a:xfrm>
            <a:off x="118974" y="1534814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050"/>
              <a:t>100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76207F96-9C8B-9D85-31F7-F667D3139598}"/>
              </a:ext>
            </a:extLst>
          </p:cNvPr>
          <p:cNvSpPr txBox="1"/>
          <p:nvPr/>
        </p:nvSpPr>
        <p:spPr>
          <a:xfrm>
            <a:off x="191855" y="1912254"/>
            <a:ext cx="5309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050"/>
              <a:t>25kDa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0F3DD3B1-4349-F699-46A2-691E0644AC7B}"/>
              </a:ext>
            </a:extLst>
          </p:cNvPr>
          <p:cNvSpPr txBox="1"/>
          <p:nvPr/>
        </p:nvSpPr>
        <p:spPr>
          <a:xfrm>
            <a:off x="187902" y="2177864"/>
            <a:ext cx="5309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050"/>
              <a:t>20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5CCAB1F-AEAA-094C-5303-6AB81EF8534B}"/>
              </a:ext>
            </a:extLst>
          </p:cNvPr>
          <p:cNvSpPr txBox="1"/>
          <p:nvPr/>
        </p:nvSpPr>
        <p:spPr>
          <a:xfrm>
            <a:off x="187902" y="2674237"/>
            <a:ext cx="53091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050"/>
              <a:t>37kDa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F479A13-DA5D-25D6-0BD7-8F7029297D63}"/>
              </a:ext>
            </a:extLst>
          </p:cNvPr>
          <p:cNvSpPr txBox="1"/>
          <p:nvPr/>
        </p:nvSpPr>
        <p:spPr>
          <a:xfrm>
            <a:off x="119613" y="3158877"/>
            <a:ext cx="599844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1050"/>
              <a:t>100kDa</a:t>
            </a:r>
          </a:p>
        </p:txBody>
      </p:sp>
      <p:cxnSp>
        <p:nvCxnSpPr>
          <p:cNvPr id="32" name="Straight Connector 31">
            <a:extLst>
              <a:ext uri="{FF2B5EF4-FFF2-40B4-BE49-F238E27FC236}">
                <a16:creationId xmlns:a16="http://schemas.microsoft.com/office/drawing/2014/main" id="{8B635499-D611-5481-4197-6E6F29F5BB4C}"/>
              </a:ext>
            </a:extLst>
          </p:cNvPr>
          <p:cNvCxnSpPr>
            <a:cxnSpLocks/>
          </p:cNvCxnSpPr>
          <p:nvPr/>
        </p:nvCxnSpPr>
        <p:spPr>
          <a:xfrm>
            <a:off x="656108" y="1668350"/>
            <a:ext cx="168633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9CAC4CEA-0D41-BD12-106D-63226BF9F801}"/>
              </a:ext>
            </a:extLst>
          </p:cNvPr>
          <p:cNvCxnSpPr>
            <a:cxnSpLocks/>
          </p:cNvCxnSpPr>
          <p:nvPr/>
        </p:nvCxnSpPr>
        <p:spPr>
          <a:xfrm>
            <a:off x="656108" y="2039212"/>
            <a:ext cx="168633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>
            <a:extLst>
              <a:ext uri="{FF2B5EF4-FFF2-40B4-BE49-F238E27FC236}">
                <a16:creationId xmlns:a16="http://schemas.microsoft.com/office/drawing/2014/main" id="{596FD6F2-C375-F83B-A7CD-1DCC5F6B5C5C}"/>
              </a:ext>
            </a:extLst>
          </p:cNvPr>
          <p:cNvCxnSpPr>
            <a:cxnSpLocks/>
          </p:cNvCxnSpPr>
          <p:nvPr/>
        </p:nvCxnSpPr>
        <p:spPr>
          <a:xfrm>
            <a:off x="656108" y="2303351"/>
            <a:ext cx="168633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Straight Connector 34">
            <a:extLst>
              <a:ext uri="{FF2B5EF4-FFF2-40B4-BE49-F238E27FC236}">
                <a16:creationId xmlns:a16="http://schemas.microsoft.com/office/drawing/2014/main" id="{706C9748-4FB2-3D53-6108-8EAAF902F536}"/>
              </a:ext>
            </a:extLst>
          </p:cNvPr>
          <p:cNvCxnSpPr>
            <a:cxnSpLocks/>
          </p:cNvCxnSpPr>
          <p:nvPr/>
        </p:nvCxnSpPr>
        <p:spPr>
          <a:xfrm>
            <a:off x="656108" y="2798142"/>
            <a:ext cx="168633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A58AC563-8151-C5C7-59F2-A7AB69266BE1}"/>
              </a:ext>
            </a:extLst>
          </p:cNvPr>
          <p:cNvCxnSpPr>
            <a:cxnSpLocks/>
          </p:cNvCxnSpPr>
          <p:nvPr/>
        </p:nvCxnSpPr>
        <p:spPr>
          <a:xfrm>
            <a:off x="656108" y="3284364"/>
            <a:ext cx="168633" cy="0"/>
          </a:xfrm>
          <a:prstGeom prst="line">
            <a:avLst/>
          </a:prstGeom>
          <a:ln w="3810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TextBox 36">
            <a:extLst>
              <a:ext uri="{FF2B5EF4-FFF2-40B4-BE49-F238E27FC236}">
                <a16:creationId xmlns:a16="http://schemas.microsoft.com/office/drawing/2014/main" id="{BB2633CF-17C0-8F17-C51E-0D435AAC5309}"/>
              </a:ext>
            </a:extLst>
          </p:cNvPr>
          <p:cNvSpPr txBox="1"/>
          <p:nvPr/>
        </p:nvSpPr>
        <p:spPr>
          <a:xfrm>
            <a:off x="479036" y="882732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A</a:t>
            </a:r>
          </a:p>
        </p:txBody>
      </p:sp>
      <p:pic>
        <p:nvPicPr>
          <p:cNvPr id="38" name="Picture 37">
            <a:extLst>
              <a:ext uri="{FF2B5EF4-FFF2-40B4-BE49-F238E27FC236}">
                <a16:creationId xmlns:a16="http://schemas.microsoft.com/office/drawing/2014/main" id="{B4B50F6C-80AC-CA76-087E-EC5FCF8A5259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1726" t="73266" r="32308" b="1226"/>
          <a:stretch/>
        </p:blipFill>
        <p:spPr>
          <a:xfrm rot="5400000">
            <a:off x="3751898" y="2078410"/>
            <a:ext cx="2391415" cy="1122037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99DEF772-2F57-5A4A-9B0F-F984F0B10946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2567" t="47712" r="31467" b="26780"/>
          <a:stretch/>
        </p:blipFill>
        <p:spPr>
          <a:xfrm rot="5400000">
            <a:off x="3751898" y="4579433"/>
            <a:ext cx="2391415" cy="1122037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40" name="Picture 39">
            <a:extLst>
              <a:ext uri="{FF2B5EF4-FFF2-40B4-BE49-F238E27FC236}">
                <a16:creationId xmlns:a16="http://schemas.microsoft.com/office/drawing/2014/main" id="{409F3F4D-6BCC-6A1B-1D03-09B499CDFFE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3221" t="24492" r="30813" b="50000"/>
          <a:stretch/>
        </p:blipFill>
        <p:spPr>
          <a:xfrm rot="5400000">
            <a:off x="4968955" y="2081883"/>
            <a:ext cx="2391415" cy="1122037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22D5ABF3-FF76-CB69-0710-381AE4D686E7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22350" r="31684" b="74492"/>
          <a:stretch/>
        </p:blipFill>
        <p:spPr>
          <a:xfrm rot="5400000">
            <a:off x="4968955" y="4579433"/>
            <a:ext cx="2391415" cy="1122037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4247EBF1-2A77-F5A2-871D-3566A5F908E1}"/>
              </a:ext>
            </a:extLst>
          </p:cNvPr>
          <p:cNvSpPr txBox="1"/>
          <p:nvPr/>
        </p:nvSpPr>
        <p:spPr>
          <a:xfrm>
            <a:off x="4386587" y="1092057"/>
            <a:ext cx="1122037" cy="276999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Control 2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7045C295-88FA-A0AA-05DB-115477513E8A}"/>
              </a:ext>
            </a:extLst>
          </p:cNvPr>
          <p:cNvSpPr txBox="1"/>
          <p:nvPr/>
        </p:nvSpPr>
        <p:spPr>
          <a:xfrm>
            <a:off x="5603644" y="1092057"/>
            <a:ext cx="1122037" cy="276999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PSEN1 Y115H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6AE0D17-208C-667F-7101-9EF466A49D66}"/>
              </a:ext>
            </a:extLst>
          </p:cNvPr>
          <p:cNvSpPr txBox="1"/>
          <p:nvPr/>
        </p:nvSpPr>
        <p:spPr>
          <a:xfrm rot="16200000">
            <a:off x="2957361" y="2500928"/>
            <a:ext cx="2391415" cy="277000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Untreated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6897328A-01C4-65B9-CB41-B40B2B982BB6}"/>
              </a:ext>
            </a:extLst>
          </p:cNvPr>
          <p:cNvSpPr txBox="1"/>
          <p:nvPr/>
        </p:nvSpPr>
        <p:spPr>
          <a:xfrm rot="16200000">
            <a:off x="2957362" y="5001952"/>
            <a:ext cx="2391414" cy="277000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200"/>
              <a:t>TNF⍺, IL1⍺, C1q</a:t>
            </a:r>
          </a:p>
        </p:txBody>
      </p:sp>
      <p:cxnSp>
        <p:nvCxnSpPr>
          <p:cNvPr id="46" name="Straight Connector 45">
            <a:extLst>
              <a:ext uri="{FF2B5EF4-FFF2-40B4-BE49-F238E27FC236}">
                <a16:creationId xmlns:a16="http://schemas.microsoft.com/office/drawing/2014/main" id="{6CD8D5CC-08FE-6C78-3B64-4755F4E7F98A}"/>
              </a:ext>
            </a:extLst>
          </p:cNvPr>
          <p:cNvCxnSpPr/>
          <p:nvPr/>
        </p:nvCxnSpPr>
        <p:spPr>
          <a:xfrm>
            <a:off x="4674143" y="5454988"/>
            <a:ext cx="0" cy="171039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>
            <a:extLst>
              <a:ext uri="{FF2B5EF4-FFF2-40B4-BE49-F238E27FC236}">
                <a16:creationId xmlns:a16="http://schemas.microsoft.com/office/drawing/2014/main" id="{AC4E74A1-78E4-4361-B68A-2860ABF4BC10}"/>
              </a:ext>
            </a:extLst>
          </p:cNvPr>
          <p:cNvCxnSpPr/>
          <p:nvPr/>
        </p:nvCxnSpPr>
        <p:spPr>
          <a:xfrm>
            <a:off x="5109415" y="5252156"/>
            <a:ext cx="0" cy="171039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B8AE2AC3-6005-2293-EF08-22BB91E5BACD}"/>
              </a:ext>
            </a:extLst>
          </p:cNvPr>
          <p:cNvCxnSpPr/>
          <p:nvPr/>
        </p:nvCxnSpPr>
        <p:spPr>
          <a:xfrm>
            <a:off x="5892242" y="5508716"/>
            <a:ext cx="0" cy="171039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Straight Connector 48">
            <a:extLst>
              <a:ext uri="{FF2B5EF4-FFF2-40B4-BE49-F238E27FC236}">
                <a16:creationId xmlns:a16="http://schemas.microsoft.com/office/drawing/2014/main" id="{FE56FC03-880A-819B-D481-F0F0274F7822}"/>
              </a:ext>
            </a:extLst>
          </p:cNvPr>
          <p:cNvCxnSpPr/>
          <p:nvPr/>
        </p:nvCxnSpPr>
        <p:spPr>
          <a:xfrm>
            <a:off x="6314358" y="5305884"/>
            <a:ext cx="0" cy="171039"/>
          </a:xfrm>
          <a:prstGeom prst="line">
            <a:avLst/>
          </a:prstGeom>
          <a:ln>
            <a:solidFill>
              <a:srgbClr val="C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49">
            <a:extLst>
              <a:ext uri="{FF2B5EF4-FFF2-40B4-BE49-F238E27FC236}">
                <a16:creationId xmlns:a16="http://schemas.microsoft.com/office/drawing/2014/main" id="{DE868139-02AE-39B2-9806-0B4DA2E0CB2D}"/>
              </a:ext>
            </a:extLst>
          </p:cNvPr>
          <p:cNvSpPr txBox="1"/>
          <p:nvPr/>
        </p:nvSpPr>
        <p:spPr>
          <a:xfrm>
            <a:off x="3968356" y="882732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B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4CA72D3F-B4A8-E1D9-68BA-BED268CA9CEF}"/>
              </a:ext>
            </a:extLst>
          </p:cNvPr>
          <p:cNvSpPr txBox="1"/>
          <p:nvPr/>
        </p:nvSpPr>
        <p:spPr>
          <a:xfrm>
            <a:off x="6955148" y="88273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C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242254A8-11E0-22F8-19A6-26A844C9FFF3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137980" y="1413692"/>
            <a:ext cx="2580679" cy="220801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10880652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0B5C68BB-0AFA-67FE-2D1C-420529AE2F9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455308" y="1738812"/>
            <a:ext cx="2758603" cy="2571931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78BC54FC-A73A-6189-B9E6-8F97140E239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11692" y="1738812"/>
            <a:ext cx="2974494" cy="2571931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4F68638-645B-C10A-3696-F55A3E8CD2A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55052" y="1729591"/>
            <a:ext cx="3002475" cy="257193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4859B588-65D8-9D1C-119A-803C1BA9DD39}"/>
              </a:ext>
            </a:extLst>
          </p:cNvPr>
          <p:cNvSpPr txBox="1"/>
          <p:nvPr/>
        </p:nvSpPr>
        <p:spPr>
          <a:xfrm>
            <a:off x="169817" y="287383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3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32E3810-4A41-58DA-E115-5768D86FC377}"/>
              </a:ext>
            </a:extLst>
          </p:cNvPr>
          <p:cNvSpPr txBox="1"/>
          <p:nvPr/>
        </p:nvSpPr>
        <p:spPr>
          <a:xfrm>
            <a:off x="169817" y="1360259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3D0EA7F-9CA5-A285-2779-F1B7ED5A9D46}"/>
              </a:ext>
            </a:extLst>
          </p:cNvPr>
          <p:cNvSpPr txBox="1"/>
          <p:nvPr/>
        </p:nvSpPr>
        <p:spPr>
          <a:xfrm>
            <a:off x="3455308" y="1360259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0BDFE58-20D7-6A0C-8340-D66AF7B2D012}"/>
              </a:ext>
            </a:extLst>
          </p:cNvPr>
          <p:cNvSpPr txBox="1"/>
          <p:nvPr/>
        </p:nvSpPr>
        <p:spPr>
          <a:xfrm>
            <a:off x="6450464" y="1360259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19268759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833B5D5-2337-0FAB-F92B-19E27522EF13}"/>
              </a:ext>
            </a:extLst>
          </p:cNvPr>
          <p:cNvSpPr txBox="1"/>
          <p:nvPr/>
        </p:nvSpPr>
        <p:spPr>
          <a:xfrm>
            <a:off x="169817" y="70409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4</a:t>
            </a:r>
          </a:p>
        </p:txBody>
      </p:sp>
      <p:pic>
        <p:nvPicPr>
          <p:cNvPr id="6" name="Picture 5" descr="A diagram of a graph&#10;&#10;Description automatically generated">
            <a:extLst>
              <a:ext uri="{FF2B5EF4-FFF2-40B4-BE49-F238E27FC236}">
                <a16:creationId xmlns:a16="http://schemas.microsoft.com/office/drawing/2014/main" id="{2ED5D29E-6385-733E-4213-F995D0F26AF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9590" y="1323754"/>
            <a:ext cx="3076797" cy="246143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379D3050-084D-F763-8631-822FAC4EAB1B}"/>
              </a:ext>
            </a:extLst>
          </p:cNvPr>
          <p:cNvSpPr txBox="1"/>
          <p:nvPr/>
        </p:nvSpPr>
        <p:spPr>
          <a:xfrm>
            <a:off x="219590" y="925033"/>
            <a:ext cx="3076797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/>
              <a:t>Untreated control vs Untreated PSEN1</a:t>
            </a:r>
          </a:p>
        </p:txBody>
      </p:sp>
      <p:pic>
        <p:nvPicPr>
          <p:cNvPr id="11" name="Picture 10" descr="A graph of red and blue dots&#10;&#10;Description automatically generated">
            <a:extLst>
              <a:ext uri="{FF2B5EF4-FFF2-40B4-BE49-F238E27FC236}">
                <a16:creationId xmlns:a16="http://schemas.microsoft.com/office/drawing/2014/main" id="{91D8AD32-6B4F-2817-D6B1-9A4C11B2D6C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14601" y="1323754"/>
            <a:ext cx="3076797" cy="246143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B586BDE1-048F-422F-6A03-1726C22A039A}"/>
              </a:ext>
            </a:extLst>
          </p:cNvPr>
          <p:cNvSpPr txBox="1"/>
          <p:nvPr/>
        </p:nvSpPr>
        <p:spPr>
          <a:xfrm>
            <a:off x="3414600" y="928578"/>
            <a:ext cx="3076797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Control untreated vs Control TI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68AD89E-2098-DAD5-1FC0-D481681EF6DD}"/>
              </a:ext>
            </a:extLst>
          </p:cNvPr>
          <p:cNvSpPr txBox="1"/>
          <p:nvPr/>
        </p:nvSpPr>
        <p:spPr>
          <a:xfrm>
            <a:off x="6609610" y="925033"/>
            <a:ext cx="3076797" cy="307777"/>
          </a:xfrm>
          <a:prstGeom prst="rect">
            <a:avLst/>
          </a:prstGeom>
          <a:noFill/>
          <a:ln>
            <a:solidFill>
              <a:schemeClr val="tx1">
                <a:lumMod val="50000"/>
                <a:lumOff val="50000"/>
              </a:schemeClr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 dirty="0"/>
              <a:t>PSEN1 untreated vs PSEN1 TIC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F8226B8F-C2DA-B12C-F7FB-CFF424870617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09610" y="1323754"/>
            <a:ext cx="3076797" cy="2461438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220361016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14E9F40-811A-911C-F5D0-78983FC711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472698"/>
            <a:ext cx="9909371" cy="638530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EBEA647-87D8-F8B1-C636-D3ED923FA87C}"/>
              </a:ext>
            </a:extLst>
          </p:cNvPr>
          <p:cNvSpPr txBox="1"/>
          <p:nvPr/>
        </p:nvSpPr>
        <p:spPr>
          <a:xfrm>
            <a:off x="169817" y="70409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5</a:t>
            </a:r>
          </a:p>
        </p:txBody>
      </p:sp>
    </p:spTree>
    <p:extLst>
      <p:ext uri="{BB962C8B-B14F-4D97-AF65-F5344CB8AC3E}">
        <p14:creationId xmlns:p14="http://schemas.microsoft.com/office/powerpoint/2010/main" val="32587058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18DF99D2-21E6-0CEF-CAF4-A84E6D4A3C57}"/>
              </a:ext>
            </a:extLst>
          </p:cNvPr>
          <p:cNvSpPr txBox="1"/>
          <p:nvPr/>
        </p:nvSpPr>
        <p:spPr>
          <a:xfrm>
            <a:off x="169817" y="287383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6</a:t>
            </a:r>
          </a:p>
        </p:txBody>
      </p:sp>
      <p:pic>
        <p:nvPicPr>
          <p:cNvPr id="6" name="Picture 5" descr="A graph and diagram of different colored bars&#10;&#10;Description automatically generated with medium confidence">
            <a:extLst>
              <a:ext uri="{FF2B5EF4-FFF2-40B4-BE49-F238E27FC236}">
                <a16:creationId xmlns:a16="http://schemas.microsoft.com/office/drawing/2014/main" id="{F14BD216-71A8-2340-B90D-874FE38DD3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66800" y="1573107"/>
            <a:ext cx="7772400" cy="310896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364678717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1B656EB8-EC9A-D156-C257-E07A911D4D27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8800" y="2571750"/>
            <a:ext cx="2664604" cy="2540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C0DC031-4E13-7981-FFC5-EF0E15FBC4D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77566" y="2571750"/>
            <a:ext cx="2750868" cy="254000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FEC0DCBF-688E-4DC7-76F6-1C1F2F0517B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82596" y="2571750"/>
            <a:ext cx="2664604" cy="2540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ED4C805-E094-A631-163B-62BB768B6734}"/>
              </a:ext>
            </a:extLst>
          </p:cNvPr>
          <p:cNvSpPr txBox="1"/>
          <p:nvPr/>
        </p:nvSpPr>
        <p:spPr>
          <a:xfrm>
            <a:off x="0" y="49290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7</a:t>
            </a:r>
          </a:p>
        </p:txBody>
      </p:sp>
    </p:spTree>
    <p:extLst>
      <p:ext uri="{BB962C8B-B14F-4D97-AF65-F5344CB8AC3E}">
        <p14:creationId xmlns:p14="http://schemas.microsoft.com/office/powerpoint/2010/main" val="539374774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C3C30D00-30E6-AF80-BE3F-AD487E6B954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031437" y="4639121"/>
            <a:ext cx="1980337" cy="202657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08FC227-766D-8814-6530-8C654572C55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90182" y="4639122"/>
            <a:ext cx="2026570" cy="202657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08ED6297-3B44-A13A-E5E0-2243F462573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395160" y="4639121"/>
            <a:ext cx="1980337" cy="202657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FBA3489C-A8D8-1EE3-766F-13EBF496A37E}"/>
              </a:ext>
            </a:extLst>
          </p:cNvPr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719280" y="122850"/>
            <a:ext cx="2095200" cy="215280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5307C0CE-11FD-2925-6746-4F2DA32CC66D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899834" y="122985"/>
            <a:ext cx="2095370" cy="215266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F041CF39-3691-2AB5-453F-09F97230D9B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38556" y="124680"/>
            <a:ext cx="2095370" cy="215266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94CF7B5-8147-D5E3-E146-F2D2DD5B750B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7084767" y="122850"/>
            <a:ext cx="2095370" cy="215266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06ED05D5-C2F6-2F63-2DB3-6428C98CC4C7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711996" y="2332565"/>
            <a:ext cx="2095370" cy="215266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CD3366BC-6C9E-9A12-2FF0-F7C6F2CDC802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4900613" y="2332565"/>
            <a:ext cx="2095200" cy="215280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C49C90A0-58CB-7D38-1C73-A9E86278EEBA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538556" y="2352735"/>
            <a:ext cx="2095370" cy="215266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3B9E09DD-AB12-7C36-A590-3C0A3DD94D96}"/>
              </a:ext>
            </a:extLst>
          </p:cNvPr>
          <p:cNvPicPr>
            <a:picLocks/>
          </p:cNvPicPr>
          <p:nvPr/>
        </p:nvPicPr>
        <p:blipFill>
          <a:blip r:embed="rId13"/>
          <a:stretch>
            <a:fillRect/>
          </a:stretch>
        </p:blipFill>
        <p:spPr>
          <a:xfrm>
            <a:off x="7084852" y="2352600"/>
            <a:ext cx="2095200" cy="215280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4928DDE0-4E55-600B-D3B8-CFD2A226826B}"/>
              </a:ext>
            </a:extLst>
          </p:cNvPr>
          <p:cNvSpPr txBox="1"/>
          <p:nvPr/>
        </p:nvSpPr>
        <p:spPr>
          <a:xfrm>
            <a:off x="0" y="49290"/>
            <a:ext cx="11993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err="1"/>
              <a:t>Suppl</a:t>
            </a:r>
            <a:r>
              <a:rPr lang="en-GB"/>
              <a:t> Fig 8</a:t>
            </a:r>
          </a:p>
        </p:txBody>
      </p:sp>
    </p:spTree>
    <p:extLst>
      <p:ext uri="{BB962C8B-B14F-4D97-AF65-F5344CB8AC3E}">
        <p14:creationId xmlns:p14="http://schemas.microsoft.com/office/powerpoint/2010/main" val="25500484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0</TotalTime>
  <Words>87</Words>
  <Application>Microsoft Macintosh PowerPoint</Application>
  <PresentationFormat>A4 Paper (210x297 mm)</PresentationFormat>
  <Paragraphs>44</Paragraphs>
  <Slides>8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8</vt:i4>
      </vt:variant>
    </vt:vector>
  </HeadingPairs>
  <TitlesOfParts>
    <vt:vector size="13" baseType="lpstr">
      <vt:lpstr>Aptos</vt:lpstr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ie</dc:creator>
  <cp:lastModifiedBy>Charlie</cp:lastModifiedBy>
  <cp:revision>2</cp:revision>
  <dcterms:created xsi:type="dcterms:W3CDTF">2024-02-05T11:16:06Z</dcterms:created>
  <dcterms:modified xsi:type="dcterms:W3CDTF">2024-09-06T11:59:58Z</dcterms:modified>
</cp:coreProperties>
</file>